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  <Override PartName="/ppt/charts/style5.xml" ContentType="application/vnd.ms-office.chartstyle+xml"/>
  <Override PartName="/ppt/charts/colors5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90" autoAdjust="0"/>
    <p:restoredTop sz="85627" autoAdjust="0"/>
  </p:normalViewPr>
  <p:slideViewPr>
    <p:cSldViewPr snapToGrid="0" snapToObjects="1">
      <p:cViewPr varScale="1">
        <p:scale>
          <a:sx n="78" d="100"/>
          <a:sy n="78" d="100"/>
        </p:scale>
        <p:origin x="-942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../embeddings/oleObject1.bin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../embeddings/oleObject2.bin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../embeddings/oleObject3.bin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../embeddings/oleObject4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B$3:$B$16</c:f>
              <c:numCache>
                <c:formatCode>General</c:formatCode>
                <c:ptCount val="14"/>
                <c:pt idx="0">
                  <c:v>51.649162456793391</c:v>
                </c:pt>
                <c:pt idx="1">
                  <c:v>60.567317574511812</c:v>
                </c:pt>
                <c:pt idx="2">
                  <c:v>260.13411078717178</c:v>
                </c:pt>
                <c:pt idx="3">
                  <c:v>16.59475218658892</c:v>
                </c:pt>
                <c:pt idx="4">
                  <c:v>753.46434494195682</c:v>
                </c:pt>
                <c:pt idx="5">
                  <c:v>438.57142857142861</c:v>
                </c:pt>
                <c:pt idx="6">
                  <c:v>0.70506592643997201</c:v>
                </c:pt>
                <c:pt idx="7">
                  <c:v>0.98736637512147696</c:v>
                </c:pt>
                <c:pt idx="8">
                  <c:v>0.73040977713874899</c:v>
                </c:pt>
                <c:pt idx="9">
                  <c:v>252.94898672257159</c:v>
                </c:pt>
                <c:pt idx="10">
                  <c:v>1850.1904761904759</c:v>
                </c:pt>
                <c:pt idx="11">
                  <c:v>210.35762876579199</c:v>
                </c:pt>
                <c:pt idx="12">
                  <c:v>10.37889290012034</c:v>
                </c:pt>
                <c:pt idx="13">
                  <c:v>811.892359442575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CCD-494D-A816-308640E886AF}"/>
            </c:ext>
          </c:extLst>
        </c:ser>
        <c:ser>
          <c:idx val="1"/>
          <c:order val="1"/>
          <c:tx>
            <c:strRef>
              <c:f>'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C$3:$C$16</c:f>
              <c:numCache>
                <c:formatCode>General</c:formatCode>
                <c:ptCount val="14"/>
                <c:pt idx="0">
                  <c:v>23.644775325711251</c:v>
                </c:pt>
                <c:pt idx="1">
                  <c:v>28.27852004110995</c:v>
                </c:pt>
                <c:pt idx="2">
                  <c:v>50.331389698736587</c:v>
                </c:pt>
                <c:pt idx="3">
                  <c:v>1.3722060252672501</c:v>
                </c:pt>
                <c:pt idx="4">
                  <c:v>485.03565505804289</c:v>
                </c:pt>
                <c:pt idx="5">
                  <c:v>116.2691933916424</c:v>
                </c:pt>
                <c:pt idx="6">
                  <c:v>1.09437890353921</c:v>
                </c:pt>
                <c:pt idx="7">
                  <c:v>1.505344995140913</c:v>
                </c:pt>
                <c:pt idx="8">
                  <c:v>1.0150970524802301</c:v>
                </c:pt>
                <c:pt idx="9">
                  <c:v>98.85499650593988</c:v>
                </c:pt>
                <c:pt idx="10">
                  <c:v>1135.740524781341</c:v>
                </c:pt>
                <c:pt idx="11">
                  <c:v>117.3187560738581</c:v>
                </c:pt>
                <c:pt idx="12">
                  <c:v>12.12726835138387</c:v>
                </c:pt>
                <c:pt idx="13">
                  <c:v>458.013455069677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CCD-494D-A816-308640E886AF}"/>
            </c:ext>
          </c:extLst>
        </c:ser>
        <c:ser>
          <c:idx val="2"/>
          <c:order val="2"/>
          <c:tx>
            <c:strRef>
              <c:f>'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D$3:$D$16</c:f>
              <c:numCache>
                <c:formatCode>General</c:formatCode>
                <c:ptCount val="14"/>
                <c:pt idx="0">
                  <c:v>36.849375166179207</c:v>
                </c:pt>
                <c:pt idx="1">
                  <c:v>43.858684480986597</c:v>
                </c:pt>
                <c:pt idx="2">
                  <c:v>141.1195335276968</c:v>
                </c:pt>
                <c:pt idx="3">
                  <c:v>6.3605442176870719</c:v>
                </c:pt>
                <c:pt idx="4">
                  <c:v>633.85489220563841</c:v>
                </c:pt>
                <c:pt idx="5">
                  <c:v>255.15257531584061</c:v>
                </c:pt>
                <c:pt idx="6">
                  <c:v>0.59680777238029203</c:v>
                </c:pt>
                <c:pt idx="7">
                  <c:v>1.528668610301263</c:v>
                </c:pt>
                <c:pt idx="8">
                  <c:v>0.61826024442846905</c:v>
                </c:pt>
                <c:pt idx="9">
                  <c:v>170.25471698113211</c:v>
                </c:pt>
                <c:pt idx="10">
                  <c:v>1457.643343051506</c:v>
                </c:pt>
                <c:pt idx="11">
                  <c:v>163.43731778425661</c:v>
                </c:pt>
                <c:pt idx="12">
                  <c:v>10.26471720818291</c:v>
                </c:pt>
                <c:pt idx="13">
                  <c:v>637.190293128303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CCD-494D-A816-308640E886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7789568"/>
        <c:axId val="178856320"/>
      </c:barChart>
      <c:catAx>
        <c:axId val="17778956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8856320"/>
        <c:crosses val="autoZero"/>
        <c:auto val="1"/>
        <c:lblAlgn val="ctr"/>
        <c:lblOffset val="100"/>
        <c:noMultiLvlLbl val="0"/>
      </c:catAx>
      <c:valAx>
        <c:axId val="178856320"/>
        <c:scaling>
          <c:orientation val="minMax"/>
          <c:min val="2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789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B$3:$B$16</c:f>
              <c:numCache>
                <c:formatCode>General</c:formatCode>
                <c:ptCount val="14"/>
                <c:pt idx="0">
                  <c:v>51.649162456793391</c:v>
                </c:pt>
                <c:pt idx="1">
                  <c:v>60.567317574511812</c:v>
                </c:pt>
                <c:pt idx="2">
                  <c:v>260.13411078717178</c:v>
                </c:pt>
                <c:pt idx="3">
                  <c:v>16.59475218658892</c:v>
                </c:pt>
                <c:pt idx="4">
                  <c:v>753.46434494195682</c:v>
                </c:pt>
                <c:pt idx="5">
                  <c:v>438.57142857142861</c:v>
                </c:pt>
                <c:pt idx="6">
                  <c:v>0.70506592643997201</c:v>
                </c:pt>
                <c:pt idx="7">
                  <c:v>0.98736637512147696</c:v>
                </c:pt>
                <c:pt idx="8">
                  <c:v>0.73040977713874899</c:v>
                </c:pt>
                <c:pt idx="9">
                  <c:v>252.94898672257159</c:v>
                </c:pt>
                <c:pt idx="10">
                  <c:v>1850.1904761904759</c:v>
                </c:pt>
                <c:pt idx="11">
                  <c:v>210.35762876579199</c:v>
                </c:pt>
                <c:pt idx="12">
                  <c:v>10.37889290012034</c:v>
                </c:pt>
                <c:pt idx="13">
                  <c:v>811.892359442575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716-4F43-BB49-66E1FA914669}"/>
            </c:ext>
          </c:extLst>
        </c:ser>
        <c:ser>
          <c:idx val="1"/>
          <c:order val="1"/>
          <c:tx>
            <c:strRef>
              <c:f>'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C$3:$C$16</c:f>
              <c:numCache>
                <c:formatCode>General</c:formatCode>
                <c:ptCount val="14"/>
                <c:pt idx="0">
                  <c:v>23.644775325711251</c:v>
                </c:pt>
                <c:pt idx="1">
                  <c:v>28.27852004110995</c:v>
                </c:pt>
                <c:pt idx="2">
                  <c:v>50.331389698736587</c:v>
                </c:pt>
                <c:pt idx="3">
                  <c:v>1.3722060252672501</c:v>
                </c:pt>
                <c:pt idx="4">
                  <c:v>485.03565505804289</c:v>
                </c:pt>
                <c:pt idx="5">
                  <c:v>116.2691933916424</c:v>
                </c:pt>
                <c:pt idx="6">
                  <c:v>1.09437890353921</c:v>
                </c:pt>
                <c:pt idx="7">
                  <c:v>1.505344995140913</c:v>
                </c:pt>
                <c:pt idx="8">
                  <c:v>1.0150970524802301</c:v>
                </c:pt>
                <c:pt idx="9">
                  <c:v>98.85499650593988</c:v>
                </c:pt>
                <c:pt idx="10">
                  <c:v>1135.740524781341</c:v>
                </c:pt>
                <c:pt idx="11">
                  <c:v>117.3187560738581</c:v>
                </c:pt>
                <c:pt idx="12">
                  <c:v>12.12726835138387</c:v>
                </c:pt>
                <c:pt idx="13">
                  <c:v>458.013455069677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716-4F43-BB49-66E1FA914669}"/>
            </c:ext>
          </c:extLst>
        </c:ser>
        <c:ser>
          <c:idx val="2"/>
          <c:order val="2"/>
          <c:tx>
            <c:strRef>
              <c:f>'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Data for the figure'!$D$3:$D$16</c:f>
              <c:numCache>
                <c:formatCode>General</c:formatCode>
                <c:ptCount val="14"/>
                <c:pt idx="0">
                  <c:v>36.849375166179207</c:v>
                </c:pt>
                <c:pt idx="1">
                  <c:v>43.858684480986597</c:v>
                </c:pt>
                <c:pt idx="2">
                  <c:v>141.1195335276968</c:v>
                </c:pt>
                <c:pt idx="3">
                  <c:v>6.3605442176870719</c:v>
                </c:pt>
                <c:pt idx="4">
                  <c:v>633.85489220563841</c:v>
                </c:pt>
                <c:pt idx="5">
                  <c:v>255.15257531584061</c:v>
                </c:pt>
                <c:pt idx="6">
                  <c:v>0.59680777238029203</c:v>
                </c:pt>
                <c:pt idx="7">
                  <c:v>1.528668610301263</c:v>
                </c:pt>
                <c:pt idx="8">
                  <c:v>0.61826024442846905</c:v>
                </c:pt>
                <c:pt idx="9">
                  <c:v>170.25471698113211</c:v>
                </c:pt>
                <c:pt idx="10">
                  <c:v>1457.643343051506</c:v>
                </c:pt>
                <c:pt idx="11">
                  <c:v>163.43731778425661</c:v>
                </c:pt>
                <c:pt idx="12">
                  <c:v>10.26471720818291</c:v>
                </c:pt>
                <c:pt idx="13">
                  <c:v>637.190293128303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716-4F43-BB49-66E1FA9146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8968832"/>
        <c:axId val="178974720"/>
      </c:barChart>
      <c:catAx>
        <c:axId val="1789688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228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974720"/>
        <c:crosses val="autoZero"/>
        <c:auto val="1"/>
        <c:lblAlgn val="ctr"/>
        <c:lblOffset val="100"/>
        <c:noMultiLvlLbl val="0"/>
      </c:catAx>
      <c:valAx>
        <c:axId val="178974720"/>
        <c:scaling>
          <c:orientation val="minMax"/>
          <c:max val="2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968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opy of Nanostring.results.all.xlsx]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F$3:$F$16</c:f>
              <c:numCache>
                <c:formatCode>General</c:formatCode>
                <c:ptCount val="14"/>
                <c:pt idx="0">
                  <c:v>67.930243092254273</c:v>
                </c:pt>
                <c:pt idx="1">
                  <c:v>73.872589129164169</c:v>
                </c:pt>
                <c:pt idx="2">
                  <c:v>443.7430555555556</c:v>
                </c:pt>
                <c:pt idx="3">
                  <c:v>52.468750000000007</c:v>
                </c:pt>
                <c:pt idx="4">
                  <c:v>572.10891089108918</c:v>
                </c:pt>
                <c:pt idx="5">
                  <c:v>145.10021892483579</c:v>
                </c:pt>
                <c:pt idx="6">
                  <c:v>180.6182965299684</c:v>
                </c:pt>
                <c:pt idx="7">
                  <c:v>0.58212877792378503</c:v>
                </c:pt>
                <c:pt idx="8">
                  <c:v>83.212339743589709</c:v>
                </c:pt>
                <c:pt idx="9">
                  <c:v>154.62770309760381</c:v>
                </c:pt>
                <c:pt idx="10">
                  <c:v>3939.6493055555561</c:v>
                </c:pt>
                <c:pt idx="11">
                  <c:v>177.35347043701799</c:v>
                </c:pt>
                <c:pt idx="12">
                  <c:v>6.6668142661621408</c:v>
                </c:pt>
                <c:pt idx="13">
                  <c:v>794.800313643492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BE1-424D-B28F-D2C3F5AF4093}"/>
            </c:ext>
          </c:extLst>
        </c:ser>
        <c:ser>
          <c:idx val="1"/>
          <c:order val="1"/>
          <c:tx>
            <c:strRef>
              <c:f>'[Copy of Nanostring.results.all.xlsx]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G$3:$G$16</c:f>
              <c:numCache>
                <c:formatCode>General</c:formatCode>
                <c:ptCount val="14"/>
                <c:pt idx="0">
                  <c:v>12.38924958478032</c:v>
                </c:pt>
                <c:pt idx="1">
                  <c:v>12.5499707773232</c:v>
                </c:pt>
                <c:pt idx="2">
                  <c:v>11.93402777777777</c:v>
                </c:pt>
                <c:pt idx="3">
                  <c:v>7.0034722222222232</c:v>
                </c:pt>
                <c:pt idx="4">
                  <c:v>109.503300330033</c:v>
                </c:pt>
                <c:pt idx="5">
                  <c:v>15.0058379956215</c:v>
                </c:pt>
                <c:pt idx="6">
                  <c:v>14.242902208201899</c:v>
                </c:pt>
                <c:pt idx="7">
                  <c:v>1.086727989487517</c:v>
                </c:pt>
                <c:pt idx="8">
                  <c:v>5.8806089743589753</c:v>
                </c:pt>
                <c:pt idx="9">
                  <c:v>32.344827586206883</c:v>
                </c:pt>
                <c:pt idx="10">
                  <c:v>620.66319444444446</c:v>
                </c:pt>
                <c:pt idx="11">
                  <c:v>54.282776349614402</c:v>
                </c:pt>
                <c:pt idx="12">
                  <c:v>5.6365026970453274</c:v>
                </c:pt>
                <c:pt idx="13">
                  <c:v>190.762676424464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BE1-424D-B28F-D2C3F5AF4093}"/>
            </c:ext>
          </c:extLst>
        </c:ser>
        <c:ser>
          <c:idx val="2"/>
          <c:order val="2"/>
          <c:tx>
            <c:strRef>
              <c:f>'[Copy of Nanostring.results.all.xlsx]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H$3:$H$16</c:f>
              <c:numCache>
                <c:formatCode>General</c:formatCode>
                <c:ptCount val="14"/>
                <c:pt idx="0">
                  <c:v>47.426241884342417</c:v>
                </c:pt>
                <c:pt idx="1">
                  <c:v>63.681472822910578</c:v>
                </c:pt>
                <c:pt idx="2">
                  <c:v>102.0052083333333</c:v>
                </c:pt>
                <c:pt idx="3">
                  <c:v>17.430555555555561</c:v>
                </c:pt>
                <c:pt idx="4">
                  <c:v>398.87871287128689</c:v>
                </c:pt>
                <c:pt idx="5">
                  <c:v>56.549744587691528</c:v>
                </c:pt>
                <c:pt idx="6">
                  <c:v>60.873817034700302</c:v>
                </c:pt>
                <c:pt idx="7">
                  <c:v>0.565045992115637</c:v>
                </c:pt>
                <c:pt idx="8">
                  <c:v>21.330929487179489</c:v>
                </c:pt>
                <c:pt idx="9">
                  <c:v>76.903565166569251</c:v>
                </c:pt>
                <c:pt idx="10">
                  <c:v>2105.8975694444448</c:v>
                </c:pt>
                <c:pt idx="11">
                  <c:v>90.093830334190216</c:v>
                </c:pt>
                <c:pt idx="12">
                  <c:v>6.7948568284893858</c:v>
                </c:pt>
                <c:pt idx="13">
                  <c:v>415.66231050705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BE1-424D-B28F-D2C3F5AF40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8935680"/>
        <c:axId val="178937216"/>
      </c:barChart>
      <c:catAx>
        <c:axId val="178935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228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937216"/>
        <c:crosses val="autoZero"/>
        <c:auto val="1"/>
        <c:lblAlgn val="ctr"/>
        <c:lblOffset val="100"/>
        <c:noMultiLvlLbl val="0"/>
      </c:catAx>
      <c:valAx>
        <c:axId val="178937216"/>
        <c:scaling>
          <c:orientation val="minMax"/>
          <c:max val="5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8935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opy of Nanostring.results.all.xlsx]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F$3:$F$16</c:f>
              <c:numCache>
                <c:formatCode>General</c:formatCode>
                <c:ptCount val="14"/>
                <c:pt idx="0">
                  <c:v>67.930243092254273</c:v>
                </c:pt>
                <c:pt idx="1">
                  <c:v>73.872589129164169</c:v>
                </c:pt>
                <c:pt idx="2">
                  <c:v>443.7430555555556</c:v>
                </c:pt>
                <c:pt idx="3">
                  <c:v>52.468750000000007</c:v>
                </c:pt>
                <c:pt idx="4">
                  <c:v>572.10891089108918</c:v>
                </c:pt>
                <c:pt idx="5">
                  <c:v>145.10021892483579</c:v>
                </c:pt>
                <c:pt idx="6">
                  <c:v>180.6182965299684</c:v>
                </c:pt>
                <c:pt idx="7">
                  <c:v>0.58212877792378503</c:v>
                </c:pt>
                <c:pt idx="8">
                  <c:v>83.212339743589709</c:v>
                </c:pt>
                <c:pt idx="9">
                  <c:v>154.62770309760381</c:v>
                </c:pt>
                <c:pt idx="10">
                  <c:v>3939.6493055555561</c:v>
                </c:pt>
                <c:pt idx="11">
                  <c:v>177.35347043701799</c:v>
                </c:pt>
                <c:pt idx="12">
                  <c:v>6.6668142661621408</c:v>
                </c:pt>
                <c:pt idx="13">
                  <c:v>794.800313643492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9E2-4F82-B106-95E6B73A0BAB}"/>
            </c:ext>
          </c:extLst>
        </c:ser>
        <c:ser>
          <c:idx val="1"/>
          <c:order val="1"/>
          <c:tx>
            <c:strRef>
              <c:f>'[Copy of Nanostring.results.all.xlsx]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G$3:$G$16</c:f>
              <c:numCache>
                <c:formatCode>General</c:formatCode>
                <c:ptCount val="14"/>
                <c:pt idx="0">
                  <c:v>12.38924958478032</c:v>
                </c:pt>
                <c:pt idx="1">
                  <c:v>12.5499707773232</c:v>
                </c:pt>
                <c:pt idx="2">
                  <c:v>11.93402777777777</c:v>
                </c:pt>
                <c:pt idx="3">
                  <c:v>7.0034722222222232</c:v>
                </c:pt>
                <c:pt idx="4">
                  <c:v>109.503300330033</c:v>
                </c:pt>
                <c:pt idx="5">
                  <c:v>15.0058379956215</c:v>
                </c:pt>
                <c:pt idx="6">
                  <c:v>14.242902208201899</c:v>
                </c:pt>
                <c:pt idx="7">
                  <c:v>1.086727989487517</c:v>
                </c:pt>
                <c:pt idx="8">
                  <c:v>5.8806089743589753</c:v>
                </c:pt>
                <c:pt idx="9">
                  <c:v>32.344827586206883</c:v>
                </c:pt>
                <c:pt idx="10">
                  <c:v>620.66319444444446</c:v>
                </c:pt>
                <c:pt idx="11">
                  <c:v>54.282776349614402</c:v>
                </c:pt>
                <c:pt idx="12">
                  <c:v>5.6365026970453274</c:v>
                </c:pt>
                <c:pt idx="13">
                  <c:v>190.762676424464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9E2-4F82-B106-95E6B73A0BAB}"/>
            </c:ext>
          </c:extLst>
        </c:ser>
        <c:ser>
          <c:idx val="2"/>
          <c:order val="2"/>
          <c:tx>
            <c:strRef>
              <c:f>'[Copy of Nanostring.results.all.xlsx]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H$3:$H$16</c:f>
              <c:numCache>
                <c:formatCode>General</c:formatCode>
                <c:ptCount val="14"/>
                <c:pt idx="0">
                  <c:v>47.426241884342417</c:v>
                </c:pt>
                <c:pt idx="1">
                  <c:v>63.681472822910578</c:v>
                </c:pt>
                <c:pt idx="2">
                  <c:v>102.0052083333333</c:v>
                </c:pt>
                <c:pt idx="3">
                  <c:v>17.430555555555561</c:v>
                </c:pt>
                <c:pt idx="4">
                  <c:v>398.87871287128689</c:v>
                </c:pt>
                <c:pt idx="5">
                  <c:v>56.549744587691528</c:v>
                </c:pt>
                <c:pt idx="6">
                  <c:v>60.873817034700302</c:v>
                </c:pt>
                <c:pt idx="7">
                  <c:v>0.565045992115637</c:v>
                </c:pt>
                <c:pt idx="8">
                  <c:v>21.330929487179489</c:v>
                </c:pt>
                <c:pt idx="9">
                  <c:v>76.903565166569251</c:v>
                </c:pt>
                <c:pt idx="10">
                  <c:v>2105.8975694444448</c:v>
                </c:pt>
                <c:pt idx="11">
                  <c:v>90.093830334190216</c:v>
                </c:pt>
                <c:pt idx="12">
                  <c:v>6.7948568284893858</c:v>
                </c:pt>
                <c:pt idx="13">
                  <c:v>415.66231050705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9E2-4F82-B106-95E6B73A0B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430912"/>
        <c:axId val="179432448"/>
      </c:barChart>
      <c:catAx>
        <c:axId val="1794309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9432448"/>
        <c:crosses val="autoZero"/>
        <c:auto val="1"/>
        <c:lblAlgn val="ctr"/>
        <c:lblOffset val="100"/>
        <c:noMultiLvlLbl val="0"/>
      </c:catAx>
      <c:valAx>
        <c:axId val="179432448"/>
        <c:scaling>
          <c:orientation val="minMax"/>
          <c:min val="5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430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opy of Nanostring.results.all.xlsx]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J$3:$J$16</c:f>
              <c:numCache>
                <c:formatCode>General</c:formatCode>
                <c:ptCount val="14"/>
                <c:pt idx="0">
                  <c:v>44.6722440944882</c:v>
                </c:pt>
                <c:pt idx="1">
                  <c:v>98.174184261036473</c:v>
                </c:pt>
                <c:pt idx="2">
                  <c:v>373.17040673211773</c:v>
                </c:pt>
                <c:pt idx="3">
                  <c:v>27.298717948717929</c:v>
                </c:pt>
                <c:pt idx="4">
                  <c:v>43.854725077871187</c:v>
                </c:pt>
                <c:pt idx="5">
                  <c:v>48.861800745871079</c:v>
                </c:pt>
                <c:pt idx="6">
                  <c:v>566.59169884169887</c:v>
                </c:pt>
                <c:pt idx="7">
                  <c:v>1.008495145631068</c:v>
                </c:pt>
                <c:pt idx="8">
                  <c:v>463.13162393162389</c:v>
                </c:pt>
                <c:pt idx="9">
                  <c:v>51.57422559906486</c:v>
                </c:pt>
                <c:pt idx="10">
                  <c:v>119.4570345408593</c:v>
                </c:pt>
                <c:pt idx="11">
                  <c:v>96.529923980649613</c:v>
                </c:pt>
                <c:pt idx="12">
                  <c:v>7.1560792171966874</c:v>
                </c:pt>
                <c:pt idx="13">
                  <c:v>80.4954765603582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B90-4CE5-AEDE-8A0A9F46C1DD}"/>
            </c:ext>
          </c:extLst>
        </c:ser>
        <c:ser>
          <c:idx val="1"/>
          <c:order val="1"/>
          <c:tx>
            <c:strRef>
              <c:f>'[Copy of Nanostring.results.all.xlsx]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K$3:$K$16</c:f>
              <c:numCache>
                <c:formatCode>General</c:formatCode>
                <c:ptCount val="14"/>
                <c:pt idx="0">
                  <c:v>30.223879466989711</c:v>
                </c:pt>
                <c:pt idx="1">
                  <c:v>57.416986564299393</c:v>
                </c:pt>
                <c:pt idx="2">
                  <c:v>131.20266479663391</c:v>
                </c:pt>
                <c:pt idx="3">
                  <c:v>7.4519230769230766</c:v>
                </c:pt>
                <c:pt idx="4">
                  <c:v>34.5271981070278</c:v>
                </c:pt>
                <c:pt idx="5">
                  <c:v>30.47123068726691</c:v>
                </c:pt>
                <c:pt idx="6">
                  <c:v>499.56660231660231</c:v>
                </c:pt>
                <c:pt idx="7">
                  <c:v>1.0521844660194171</c:v>
                </c:pt>
                <c:pt idx="8">
                  <c:v>419.44273504273502</c:v>
                </c:pt>
                <c:pt idx="9">
                  <c:v>28.48918760958502</c:v>
                </c:pt>
                <c:pt idx="10">
                  <c:v>89.399293629706435</c:v>
                </c:pt>
                <c:pt idx="11">
                  <c:v>74.932688320663402</c:v>
                </c:pt>
                <c:pt idx="12">
                  <c:v>7.569236974964868</c:v>
                </c:pt>
                <c:pt idx="13">
                  <c:v>67.0143318407505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B90-4CE5-AEDE-8A0A9F46C1DD}"/>
            </c:ext>
          </c:extLst>
        </c:ser>
        <c:ser>
          <c:idx val="2"/>
          <c:order val="2"/>
          <c:tx>
            <c:strRef>
              <c:f>'[Copy of Nanostring.results.all.xlsx]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L$3:$L$16</c:f>
              <c:numCache>
                <c:formatCode>General</c:formatCode>
                <c:ptCount val="14"/>
                <c:pt idx="0">
                  <c:v>34.638022410660213</c:v>
                </c:pt>
                <c:pt idx="1">
                  <c:v>79.420345489443406</c:v>
                </c:pt>
                <c:pt idx="2">
                  <c:v>235.3625525946704</c:v>
                </c:pt>
                <c:pt idx="3">
                  <c:v>15.830128205128201</c:v>
                </c:pt>
                <c:pt idx="4">
                  <c:v>35.628036308704203</c:v>
                </c:pt>
                <c:pt idx="5">
                  <c:v>35.567288225892362</c:v>
                </c:pt>
                <c:pt idx="6">
                  <c:v>481.46621621621603</c:v>
                </c:pt>
                <c:pt idx="7">
                  <c:v>0.87014563106796095</c:v>
                </c:pt>
                <c:pt idx="8">
                  <c:v>425.09316239316252</c:v>
                </c:pt>
                <c:pt idx="9">
                  <c:v>39.456165984804208</c:v>
                </c:pt>
                <c:pt idx="10">
                  <c:v>90.819421942842354</c:v>
                </c:pt>
                <c:pt idx="11">
                  <c:v>73.885556323427735</c:v>
                </c:pt>
                <c:pt idx="12">
                  <c:v>6.2162207880081199</c:v>
                </c:pt>
                <c:pt idx="13">
                  <c:v>62.2207804075664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B90-4CE5-AEDE-8A0A9F46C1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746304"/>
        <c:axId val="179747840"/>
      </c:barChart>
      <c:catAx>
        <c:axId val="17974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228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747840"/>
        <c:crosses val="autoZero"/>
        <c:auto val="1"/>
        <c:lblAlgn val="ctr"/>
        <c:lblOffset val="100"/>
        <c:noMultiLvlLbl val="0"/>
      </c:catAx>
      <c:valAx>
        <c:axId val="17974784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746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opy of Nanostring.results.all.xlsx]Data for the figure'!$B$2</c:f>
              <c:strCache>
                <c:ptCount val="1"/>
                <c:pt idx="0">
                  <c:v>500 U/ml IFN-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J$3:$J$16</c:f>
              <c:numCache>
                <c:formatCode>General</c:formatCode>
                <c:ptCount val="14"/>
                <c:pt idx="0">
                  <c:v>44.6722440944882</c:v>
                </c:pt>
                <c:pt idx="1">
                  <c:v>98.174184261036473</c:v>
                </c:pt>
                <c:pt idx="2">
                  <c:v>373.17040673211773</c:v>
                </c:pt>
                <c:pt idx="3">
                  <c:v>27.298717948717929</c:v>
                </c:pt>
                <c:pt idx="4">
                  <c:v>43.854725077871187</c:v>
                </c:pt>
                <c:pt idx="5">
                  <c:v>48.861800745871079</c:v>
                </c:pt>
                <c:pt idx="6">
                  <c:v>566.59169884169887</c:v>
                </c:pt>
                <c:pt idx="7">
                  <c:v>1.008495145631068</c:v>
                </c:pt>
                <c:pt idx="8">
                  <c:v>463.13162393162389</c:v>
                </c:pt>
                <c:pt idx="9">
                  <c:v>51.57422559906486</c:v>
                </c:pt>
                <c:pt idx="10">
                  <c:v>119.4570345408593</c:v>
                </c:pt>
                <c:pt idx="11">
                  <c:v>96.529923980649613</c:v>
                </c:pt>
                <c:pt idx="12">
                  <c:v>7.1560792171966874</c:v>
                </c:pt>
                <c:pt idx="13">
                  <c:v>80.4954765603582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F5C-4529-BB94-DDF0D8FE6E60}"/>
            </c:ext>
          </c:extLst>
        </c:ser>
        <c:ser>
          <c:idx val="1"/>
          <c:order val="1"/>
          <c:tx>
            <c:strRef>
              <c:f>'[Copy of Nanostring.results.all.xlsx]Data for the figure'!$C$2</c:f>
              <c:strCache>
                <c:ptCount val="1"/>
                <c:pt idx="0">
                  <c:v> IFN-g + CQ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K$3:$K$16</c:f>
              <c:numCache>
                <c:formatCode>General</c:formatCode>
                <c:ptCount val="14"/>
                <c:pt idx="0">
                  <c:v>30.223879466989711</c:v>
                </c:pt>
                <c:pt idx="1">
                  <c:v>57.416986564299393</c:v>
                </c:pt>
                <c:pt idx="2">
                  <c:v>131.20266479663391</c:v>
                </c:pt>
                <c:pt idx="3">
                  <c:v>7.4519230769230766</c:v>
                </c:pt>
                <c:pt idx="4">
                  <c:v>34.5271981070278</c:v>
                </c:pt>
                <c:pt idx="5">
                  <c:v>30.47123068726691</c:v>
                </c:pt>
                <c:pt idx="6">
                  <c:v>499.56660231660231</c:v>
                </c:pt>
                <c:pt idx="7">
                  <c:v>1.0521844660194171</c:v>
                </c:pt>
                <c:pt idx="8">
                  <c:v>419.44273504273502</c:v>
                </c:pt>
                <c:pt idx="9">
                  <c:v>28.48918760958502</c:v>
                </c:pt>
                <c:pt idx="10">
                  <c:v>89.399293629706435</c:v>
                </c:pt>
                <c:pt idx="11">
                  <c:v>74.932688320663402</c:v>
                </c:pt>
                <c:pt idx="12">
                  <c:v>7.569236974964868</c:v>
                </c:pt>
                <c:pt idx="13">
                  <c:v>67.0143318407505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F5C-4529-BB94-DDF0D8FE6E60}"/>
            </c:ext>
          </c:extLst>
        </c:ser>
        <c:ser>
          <c:idx val="2"/>
          <c:order val="2"/>
          <c:tx>
            <c:strRef>
              <c:f>'[Copy of Nanostring.results.all.xlsx]Data for the figure'!$D$2</c:f>
              <c:strCache>
                <c:ptCount val="1"/>
                <c:pt idx="0">
                  <c:v> IFN-g + T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[Copy of Nanostring.results.all.xlsx]Data for the figure'!$A$3:$A$16</c:f>
              <c:strCache>
                <c:ptCount val="14"/>
                <c:pt idx="0">
                  <c:v>HLA-DMA</c:v>
                </c:pt>
                <c:pt idx="1">
                  <c:v>HLA-DMB</c:v>
                </c:pt>
                <c:pt idx="2">
                  <c:v>HLA-DOA</c:v>
                </c:pt>
                <c:pt idx="3">
                  <c:v>HLA-DOB</c:v>
                </c:pt>
                <c:pt idx="4">
                  <c:v>HLA-DPA1</c:v>
                </c:pt>
                <c:pt idx="5">
                  <c:v>HLA-DPB1</c:v>
                </c:pt>
                <c:pt idx="6">
                  <c:v>HLA-DQA1</c:v>
                </c:pt>
                <c:pt idx="7">
                  <c:v>HLA-DQA2</c:v>
                </c:pt>
                <c:pt idx="8">
                  <c:v>HLA-DQB1</c:v>
                </c:pt>
                <c:pt idx="9">
                  <c:v>HLA-DQB2</c:v>
                </c:pt>
                <c:pt idx="10">
                  <c:v>HLA-DRA</c:v>
                </c:pt>
                <c:pt idx="11">
                  <c:v>HLA-DRB5</c:v>
                </c:pt>
                <c:pt idx="12">
                  <c:v>HLA-G</c:v>
                </c:pt>
                <c:pt idx="13">
                  <c:v>HLA-DRB1</c:v>
                </c:pt>
              </c:strCache>
            </c:strRef>
          </c:cat>
          <c:val>
            <c:numRef>
              <c:f>'[Copy of Nanostring.results.all.xlsx]Data for the figure'!$L$3:$L$16</c:f>
              <c:numCache>
                <c:formatCode>General</c:formatCode>
                <c:ptCount val="14"/>
                <c:pt idx="0">
                  <c:v>34.638022410660213</c:v>
                </c:pt>
                <c:pt idx="1">
                  <c:v>79.420345489443406</c:v>
                </c:pt>
                <c:pt idx="2">
                  <c:v>235.3625525946704</c:v>
                </c:pt>
                <c:pt idx="3">
                  <c:v>15.830128205128201</c:v>
                </c:pt>
                <c:pt idx="4">
                  <c:v>35.628036308704203</c:v>
                </c:pt>
                <c:pt idx="5">
                  <c:v>35.567288225892362</c:v>
                </c:pt>
                <c:pt idx="6">
                  <c:v>481.46621621621603</c:v>
                </c:pt>
                <c:pt idx="7">
                  <c:v>0.87014563106796095</c:v>
                </c:pt>
                <c:pt idx="8">
                  <c:v>425.09316239316252</c:v>
                </c:pt>
                <c:pt idx="9">
                  <c:v>39.456165984804208</c:v>
                </c:pt>
                <c:pt idx="10">
                  <c:v>90.819421942842354</c:v>
                </c:pt>
                <c:pt idx="11">
                  <c:v>73.885556323427735</c:v>
                </c:pt>
                <c:pt idx="12">
                  <c:v>6.2162207880081199</c:v>
                </c:pt>
                <c:pt idx="13">
                  <c:v>62.2207804075664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F5C-4529-BB94-DDF0D8FE6E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758208"/>
        <c:axId val="179759744"/>
      </c:barChart>
      <c:catAx>
        <c:axId val="1797582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79759744"/>
        <c:crosses val="autoZero"/>
        <c:auto val="1"/>
        <c:lblAlgn val="ctr"/>
        <c:lblOffset val="100"/>
        <c:noMultiLvlLbl val="0"/>
      </c:catAx>
      <c:valAx>
        <c:axId val="179759744"/>
        <c:scaling>
          <c:orientation val="minMax"/>
          <c:min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758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BE3766-E641-AB46-BB52-3850097C33DA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F8F50-7C1F-1445-A60C-715B0E078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4170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C5C442-2F04-D247-AFC1-2689154C4B54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43055-29F0-6B41-9D6F-0A67EC9F79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91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smtClean="0"/>
              <a:t>Figure S4</a:t>
            </a:r>
            <a:r>
              <a:rPr lang="en-US" sz="1200" b="1" smtClean="0"/>
              <a:t>. </a:t>
            </a:r>
            <a:r>
              <a:rPr lang="en-US" sz="1200" b="1" dirty="0" err="1"/>
              <a:t>NanoString</a:t>
            </a:r>
            <a:r>
              <a:rPr lang="en-US" sz="1200" b="1" dirty="0"/>
              <a:t> assessment of selected</a:t>
            </a:r>
            <a:r>
              <a:rPr lang="en-US" sz="1200" b="1" baseline="0" dirty="0"/>
              <a:t> HLA gene expression. </a:t>
            </a:r>
            <a:r>
              <a:rPr lang="en-US" sz="1200" b="0" baseline="0" dirty="0"/>
              <a:t>MIAMI cells were treated with </a:t>
            </a:r>
            <a:r>
              <a:rPr lang="en-US" sz="1200" b="0" baseline="0" dirty="0" err="1"/>
              <a:t>IFN</a:t>
            </a:r>
            <a:r>
              <a:rPr lang="en-US" sz="1200" b="0" baseline="0" dirty="0" err="1">
                <a:latin typeface="Symbol" panose="05050102010706020507" pitchFamily="18" charset="2"/>
              </a:rPr>
              <a:t>g</a:t>
            </a:r>
            <a:r>
              <a:rPr lang="en-US" sz="1200" b="0" baseline="0" dirty="0"/>
              <a:t> (blue bars), </a:t>
            </a:r>
            <a:r>
              <a:rPr lang="en-US" sz="1200" b="0" baseline="0" dirty="0" err="1"/>
              <a:t>IFN</a:t>
            </a:r>
            <a:r>
              <a:rPr lang="en-US" sz="1200" b="0" baseline="0" dirty="0" err="1">
                <a:latin typeface="Symbol" panose="05050102010706020507" pitchFamily="18" charset="2"/>
              </a:rPr>
              <a:t>g</a:t>
            </a:r>
            <a:r>
              <a:rPr lang="en-US" sz="1200" b="0" baseline="0" dirty="0"/>
              <a:t> + CQ (red bars) or </a:t>
            </a:r>
            <a:r>
              <a:rPr lang="en-US" sz="1200" b="0" baseline="0" dirty="0" err="1"/>
              <a:t>IFNg</a:t>
            </a:r>
            <a:r>
              <a:rPr lang="en-US" sz="1200" b="0" baseline="0" dirty="0"/>
              <a:t> + TX (gray bars). Validation of RNA sequencing data was performed for selected genes using MIAMI cell donor 3515 (A), while donor 4381 (B) and adipose-derived MSCs (C) were used for comparison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43055-29F0-6B41-9D6F-0A67EC9F79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7234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33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90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30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960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4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70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5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718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552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672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25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55962" y="1100376"/>
            <a:ext cx="3977888" cy="4629151"/>
            <a:chOff x="167368" y="1162049"/>
            <a:chExt cx="5993947" cy="4629151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228342"/>
                </p:ext>
              </p:extLst>
            </p:nvPr>
          </p:nvGraphicFramePr>
          <p:xfrm>
            <a:off x="167368" y="1162049"/>
            <a:ext cx="5993947" cy="23975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13707985"/>
                </p:ext>
              </p:extLst>
            </p:nvPr>
          </p:nvGraphicFramePr>
          <p:xfrm>
            <a:off x="276226" y="3393621"/>
            <a:ext cx="5885089" cy="23975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9" name="Group 8"/>
          <p:cNvGrpSpPr/>
          <p:nvPr/>
        </p:nvGrpSpPr>
        <p:grpSpPr>
          <a:xfrm>
            <a:off x="4285760" y="1100376"/>
            <a:ext cx="3785105" cy="4629151"/>
            <a:chOff x="450563" y="1847849"/>
            <a:chExt cx="5858206" cy="4629151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30951261"/>
                </p:ext>
              </p:extLst>
            </p:nvPr>
          </p:nvGraphicFramePr>
          <p:xfrm>
            <a:off x="554740" y="4245428"/>
            <a:ext cx="5754029" cy="22315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38970058"/>
                </p:ext>
              </p:extLst>
            </p:nvPr>
          </p:nvGraphicFramePr>
          <p:xfrm>
            <a:off x="450563" y="1847849"/>
            <a:ext cx="5858206" cy="25549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2" name="TextBox 1"/>
          <p:cNvSpPr txBox="1"/>
          <p:nvPr/>
        </p:nvSpPr>
        <p:spPr>
          <a:xfrm rot="16200000">
            <a:off x="3333791" y="2970201"/>
            <a:ext cx="18309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Fold increase compared to control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793042" y="3054808"/>
            <a:ext cx="18309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Fold increase compared to control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8206690" y="964719"/>
            <a:ext cx="3933549" cy="4734457"/>
            <a:chOff x="6565676" y="1742543"/>
            <a:chExt cx="5380201" cy="4734457"/>
          </a:xfrm>
        </p:grpSpPr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43510984"/>
                </p:ext>
              </p:extLst>
            </p:nvPr>
          </p:nvGraphicFramePr>
          <p:xfrm>
            <a:off x="6565676" y="4103649"/>
            <a:ext cx="5380201" cy="23733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77595113"/>
                </p:ext>
              </p:extLst>
            </p:nvPr>
          </p:nvGraphicFramePr>
          <p:xfrm>
            <a:off x="6565676" y="1742543"/>
            <a:ext cx="5380201" cy="25234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sp>
        <p:nvSpPr>
          <p:cNvPr id="16" name="TextBox 15"/>
          <p:cNvSpPr txBox="1"/>
          <p:nvPr/>
        </p:nvSpPr>
        <p:spPr>
          <a:xfrm rot="16200000">
            <a:off x="7223303" y="2935064"/>
            <a:ext cx="18309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Fold increase compared to control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22433" y="51263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285760" y="503054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146462" y="492787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20" name="Rectangle 19"/>
          <p:cNvSpPr/>
          <p:nvPr/>
        </p:nvSpPr>
        <p:spPr>
          <a:xfrm>
            <a:off x="10876262" y="6304758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643314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62</TotalTime>
  <Words>92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rella Rossi</dc:creator>
  <cp:lastModifiedBy>RTORRES</cp:lastModifiedBy>
  <cp:revision>243</cp:revision>
  <cp:lastPrinted>2019-01-20T19:05:41Z</cp:lastPrinted>
  <dcterms:created xsi:type="dcterms:W3CDTF">2019-01-09T21:33:31Z</dcterms:created>
  <dcterms:modified xsi:type="dcterms:W3CDTF">2019-11-30T01:09:14Z</dcterms:modified>
</cp:coreProperties>
</file>